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110" d="100"/>
          <a:sy n="110" d="100"/>
        </p:scale>
        <p:origin x="2292" y="-21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CF0-4EE5-BBAB-F409E8585DC5}"/>
              </c:ext>
            </c:extLst>
          </c:dPt>
          <c:cat>
            <c:strRef>
              <c:f>Sheet1!$H$3:$I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Sheet1!$H$4:$I$4</c:f>
              <c:numCache>
                <c:formatCode>General</c:formatCode>
                <c:ptCount val="2"/>
                <c:pt idx="0">
                  <c:v>868.71</c:v>
                </c:pt>
                <c:pt idx="1">
                  <c:v>1938.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F0-4EE5-BBAB-F409E8585D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3394432"/>
        <c:axId val="93395968"/>
      </c:barChart>
      <c:catAx>
        <c:axId val="933944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3395968"/>
        <c:crosses val="autoZero"/>
        <c:auto val="1"/>
        <c:lblAlgn val="ctr"/>
        <c:lblOffset val="100"/>
        <c:noMultiLvlLbl val="0"/>
      </c:catAx>
      <c:valAx>
        <c:axId val="93395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Median-MF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33944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F35-459B-8A1C-FA8CE126F537}"/>
              </c:ext>
            </c:extLst>
          </c:dPt>
          <c:cat>
            <c:strRef>
              <c:f>Sheet1!$O$3:$P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Sheet1!$O$4:$P$4</c:f>
              <c:numCache>
                <c:formatCode>General</c:formatCode>
                <c:ptCount val="2"/>
                <c:pt idx="0">
                  <c:v>517.15</c:v>
                </c:pt>
                <c:pt idx="1">
                  <c:v>1862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35-459B-8A1C-FA8CE126F5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4120960"/>
        <c:axId val="94135040"/>
      </c:barChart>
      <c:catAx>
        <c:axId val="941209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4135040"/>
        <c:crosses val="autoZero"/>
        <c:auto val="1"/>
        <c:lblAlgn val="ctr"/>
        <c:lblOffset val="100"/>
        <c:noMultiLvlLbl val="0"/>
      </c:catAx>
      <c:valAx>
        <c:axId val="941350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Median MF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4120960"/>
        <c:crosses val="autoZero"/>
        <c:crossBetween val="between"/>
        <c:majorUnit val="500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88A-4CC3-A89D-4707F8A62AC2}"/>
              </c:ext>
            </c:extLst>
          </c:dPt>
          <c:cat>
            <c:strRef>
              <c:f>Sheet1!$AA$3:$AB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Sheet1!$AA$4:$AB$4</c:f>
              <c:numCache>
                <c:formatCode>General</c:formatCode>
                <c:ptCount val="2"/>
                <c:pt idx="0">
                  <c:v>309.25</c:v>
                </c:pt>
                <c:pt idx="1">
                  <c:v>618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88A-4CC3-A89D-4707F8A62A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4167808"/>
        <c:axId val="94169344"/>
      </c:barChart>
      <c:catAx>
        <c:axId val="94167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4169344"/>
        <c:crosses val="autoZero"/>
        <c:auto val="1"/>
        <c:lblAlgn val="ctr"/>
        <c:lblOffset val="100"/>
        <c:noMultiLvlLbl val="0"/>
      </c:catAx>
      <c:valAx>
        <c:axId val="941693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Median MFI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94167808"/>
        <c:crosses val="autoZero"/>
        <c:crossBetween val="between"/>
        <c:majorUnit val="200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314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143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203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277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964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575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378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30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41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992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911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C2EBF-3D5B-4F01-95A8-19AF22180D5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72B7F-5AB5-4CAB-A35C-0EBEC37715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254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chart" Target="../charts/chart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6886" t="5551" r="54850" b="17612"/>
          <a:stretch/>
        </p:blipFill>
        <p:spPr>
          <a:xfrm>
            <a:off x="2482687" y="623815"/>
            <a:ext cx="2293708" cy="187988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8354" t="4805" r="49679" b="15622"/>
          <a:stretch/>
        </p:blipFill>
        <p:spPr>
          <a:xfrm>
            <a:off x="416773" y="623815"/>
            <a:ext cx="2107365" cy="194680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8907" t="5303" r="49233" b="16118"/>
          <a:stretch/>
        </p:blipFill>
        <p:spPr>
          <a:xfrm>
            <a:off x="4695644" y="609729"/>
            <a:ext cx="2002867" cy="192247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 rot="16200000">
            <a:off x="-299664" y="1282273"/>
            <a:ext cx="1507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# c-Kit+ cells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502747" y="731329"/>
            <a:ext cx="132565" cy="6813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128904" y="2629019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GRP78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94656" y="2642589"/>
            <a:ext cx="5597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XBP1</a:t>
            </a:r>
            <a:endParaRPr lang="en-US" sz="1400" dirty="0"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00148" y="2646113"/>
            <a:ext cx="5361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cs typeface="Arial" pitchFamily="34" charset="0"/>
              </a:rPr>
              <a:t>ATF6</a:t>
            </a:r>
            <a:endParaRPr lang="en-US" sz="1400" dirty="0">
              <a:cs typeface="Arial" pitchFamily="34" charset="0"/>
            </a:endParaRP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7754243"/>
              </p:ext>
            </p:extLst>
          </p:nvPr>
        </p:nvGraphicFramePr>
        <p:xfrm>
          <a:off x="300089" y="2842790"/>
          <a:ext cx="1991483" cy="1676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5446655"/>
              </p:ext>
            </p:extLst>
          </p:nvPr>
        </p:nvGraphicFramePr>
        <p:xfrm>
          <a:off x="2456121" y="2835556"/>
          <a:ext cx="2105121" cy="17398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1258900"/>
              </p:ext>
            </p:extLst>
          </p:nvPr>
        </p:nvGraphicFramePr>
        <p:xfrm>
          <a:off x="4480058" y="2835556"/>
          <a:ext cx="2040180" cy="17614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Rectangle 12"/>
          <p:cNvSpPr/>
          <p:nvPr/>
        </p:nvSpPr>
        <p:spPr>
          <a:xfrm>
            <a:off x="457199" y="4941838"/>
            <a:ext cx="621792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ure 2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of ER stress in c-Kit expressing B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s treated with TM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µg/m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for 16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urs. This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cell population represents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hematopoietic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genitor cel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raction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fication of quantified Median Fluorescence intensity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FI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0143" y="37263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42695" y="2495774"/>
            <a:ext cx="270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597395" y="773180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cs typeface="Arial" pitchFamily="34" charset="0"/>
              </a:rPr>
              <a:t>GRP78</a:t>
            </a:r>
            <a:endParaRPr lang="en-US" sz="1200" dirty="0"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863147" y="786750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cs typeface="Arial" pitchFamily="34" charset="0"/>
              </a:rPr>
              <a:t>XBP1</a:t>
            </a:r>
            <a:endParaRPr lang="en-US" sz="1200" dirty="0"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968639" y="790274"/>
            <a:ext cx="486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cs typeface="Arial" pitchFamily="34" charset="0"/>
              </a:rPr>
              <a:t>ATF6</a:t>
            </a:r>
            <a:endParaRPr lang="en-US" sz="1200" dirty="0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03453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68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noy, Gautam</dc:creator>
  <cp:lastModifiedBy>Zhang, Xin</cp:lastModifiedBy>
  <cp:revision>8</cp:revision>
  <dcterms:created xsi:type="dcterms:W3CDTF">2018-02-02T15:31:31Z</dcterms:created>
  <dcterms:modified xsi:type="dcterms:W3CDTF">2018-02-08T17:49:39Z</dcterms:modified>
</cp:coreProperties>
</file>